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4"/>
  </p:notesMasterIdLst>
  <p:sldIdLst>
    <p:sldId id="256" r:id="rId2"/>
    <p:sldId id="311" r:id="rId3"/>
    <p:sldId id="287" r:id="rId4"/>
    <p:sldId id="288" r:id="rId5"/>
    <p:sldId id="289" r:id="rId6"/>
    <p:sldId id="290" r:id="rId7"/>
    <p:sldId id="291" r:id="rId8"/>
    <p:sldId id="293" r:id="rId9"/>
    <p:sldId id="270" r:id="rId10"/>
    <p:sldId id="295" r:id="rId11"/>
    <p:sldId id="294" r:id="rId12"/>
    <p:sldId id="297" r:id="rId13"/>
    <p:sldId id="277" r:id="rId14"/>
    <p:sldId id="299" r:id="rId15"/>
    <p:sldId id="301" r:id="rId16"/>
    <p:sldId id="303" r:id="rId17"/>
    <p:sldId id="305" r:id="rId18"/>
    <p:sldId id="307" r:id="rId19"/>
    <p:sldId id="309" r:id="rId20"/>
    <p:sldId id="280" r:id="rId21"/>
    <p:sldId id="281" r:id="rId22"/>
    <p:sldId id="282" r:id="rId2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818"/>
    <p:restoredTop sz="94694"/>
  </p:normalViewPr>
  <p:slideViewPr>
    <p:cSldViewPr snapToGrid="0">
      <p:cViewPr varScale="1">
        <p:scale>
          <a:sx n="108" d="100"/>
          <a:sy n="108" d="100"/>
        </p:scale>
        <p:origin x="8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9E0875-7E84-8644-8746-6B9FD72837E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3778DD-35D3-9848-B9A4-C075910FF9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796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11D593-EB95-2F4D-BC98-EDAE1C383F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4891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9D846A1-BE63-AA0A-DEAB-6ACBD65B4F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013E11E8-8AAB-1B58-4C19-EC7F059289D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F3F5EAF-B862-D58A-F54F-25042612BD4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E5A08B2-5D84-B3A7-2EA1-E8068FDD14A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3778DD-35D3-9848-B9A4-C075910FF980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45102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E3B7AE7-1CF2-4AEF-7333-5276C44156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0402191-A438-510C-820E-BFABCE7CDF0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17C552E9-9B13-75B8-A51F-33E77D31A5B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C2A718-43C6-9742-1656-78F7B5F2D45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3778DD-35D3-9848-B9A4-C075910FF980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65148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E2C41C-464A-BE52-BD23-3E24FE380A0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B875B5B6-5A6D-F847-1B60-1F7BA4AB99D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50F96852-D6DD-0B35-B7C4-7DC9166266D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FB11A6-05FA-1D79-19EF-66D1D872FBB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3778DD-35D3-9848-B9A4-C075910FF980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27603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3C9486-3387-CDA2-033C-0665D8DAAA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659EA70-CCC7-DECB-6E89-F21CA641407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8A23279-E0DF-CD36-6F82-644F7C0A585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346F94-1008-212F-CD7D-4E4B4334172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3778DD-35D3-9848-B9A4-C075910FF980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57193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9413581-501B-80C6-96F0-D63E4F8C70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209D7718-94FF-3C46-E944-91FEABA34AC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5D5AE1E-6412-324B-BCCE-6E4F58ED208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6984FAB-4AA0-B8BE-A371-1DA1041E013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3778DD-35D3-9848-B9A4-C075910FF980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1089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B6A6A-EF82-552F-169F-2DD6FEAF1D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D8124B-509F-9509-4197-0EFBC45711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5E92AD-AC40-B7FC-73F4-102816896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E04DE3-5134-C407-892B-5097B8AA5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7DDA63-DA95-D661-1EB6-EB2BBFCF1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867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DCA4EB-3F15-ABAE-CCA6-6F75765D56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2D7975-24CF-AD7F-289C-ED1E1B24C4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62C4EF-5538-AA57-D733-16537D60F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041E69-510B-DB2F-C17C-E2255AEEB4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6E405C-7D29-5FEB-5EC9-31C3C00BED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616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D7A9FA-5411-AC6C-C5E4-767FF4BE90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CCA35E-A4A6-F37D-F32F-747A919928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B24BD5-997C-C683-0389-508350DA8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13D362-A8BC-183B-D815-584334356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35E98-27B2-2C19-6D0A-6A43D844C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381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E6D71-4F64-CF9D-B927-64185BFE55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FB9CEC-52B8-D8B8-D368-E3A9D6E24A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4C5D9E-28B8-F198-5207-35F63A31C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C9EE5B-C226-675D-BB59-052C4CFA2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B82742-ABB6-5E01-1F2B-904877DF5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451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479EBD-C45B-5EE2-E7C9-F363FA2E5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A1452E-3DC8-D0A8-A7FD-D56531386E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FE7B87-9978-82E8-FB30-EBBFE38593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05971A-3FED-3EBF-373F-5099DA6CB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73EF6F-5F7C-0DC1-1B19-B8D3B438B5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9416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387F94-019E-76B8-EF8E-EF77CDEC0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C0120E-2D8D-CDEC-1203-377A9E7D31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F63891-D5AA-DDC8-B4C4-4E9596601B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1815A4-28B9-45B9-9D39-BFF5F7827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C2220F-C41A-2344-E882-124ABCA7E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74FE26-E0B8-01DD-58C9-A682A2F66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359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F0C00B-76A3-F7FD-1A90-3F7BF49B23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26FE45-3E67-3138-6FB8-CD27B8BEB8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0EB35B-F5DB-9288-5EBD-3E6924B6F4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4CF968-E322-C353-DB00-5973259E08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FD1936-6367-67CD-92F2-B50ECEA127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DFEA2-7C89-4C97-F223-EFDF13D13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8627E6-6619-1D20-749E-589241E64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3E9CFB-DDAD-916E-A45A-31246EF87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468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975801-B4C5-2994-68C7-7989A7ECD6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BDDD264-5798-C42C-002A-8B5C3E62D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8EEAAE-6CE5-0AC7-7599-BF260CE53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3B55AE-1BA9-ECC5-EC04-74010A7DE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159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B8D8FD-47E5-0F89-AEA0-171111557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11D4996-37DF-6EDE-E6D1-9B2F65FCF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326207-F397-BB60-9FEC-88C4266FF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244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03B7EC-A239-4EA9-CD0B-BB3D82C69C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7E09C0-F0AD-98C0-5355-CC58B413B8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25A209-8D10-F37F-4D3A-9E050844A6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E26262-E51A-34E8-5D8D-96E6839AD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6C719C-C96A-9ACB-6105-0FA55BB62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F7762F-57CF-4401-CF36-309B2C569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870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B992EF-3D09-9C4A-0F06-F5202B4109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8F294B-6EDB-AA7B-452C-B912E4C09E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3B5E63-2DCC-72AE-1AD8-ED80E5BAD1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3AAA89-5188-2ECE-AC6D-263B34349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81B5F0-9981-C3AA-A0DE-369A8DE64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2AB878-008F-E76E-A62A-4F87EA937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499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1E5127-B0BB-F1A1-855C-F5E345D04F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770CE7-2A36-7D0C-F83B-2E3937B4E7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AD714B-BBB9-4AD8-3277-DA69DFA08A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80FB695-164B-B34A-A762-53095804A870}" type="datetimeFigureOut">
              <a:rPr lang="en-US" smtClean="0"/>
              <a:t>5/1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5A5A60-6846-1469-27CA-0A6CDC6D89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181C26-E0AB-1B21-FD7F-9B397E4DC7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8B116A-4C01-E349-9167-8511E7D29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398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ight Arrow 3">
            <a:extLst>
              <a:ext uri="{FF2B5EF4-FFF2-40B4-BE49-F238E27FC236}">
                <a16:creationId xmlns:a16="http://schemas.microsoft.com/office/drawing/2014/main" id="{0CD4C20E-44DE-D9F1-621E-D5883DCA218D}"/>
              </a:ext>
            </a:extLst>
          </p:cNvPr>
          <p:cNvSpPr/>
          <p:nvPr/>
        </p:nvSpPr>
        <p:spPr>
          <a:xfrm>
            <a:off x="980233" y="3474719"/>
            <a:ext cx="10389326" cy="426720"/>
          </a:xfrm>
          <a:prstGeom prst="rightArrow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91FB6388-0F72-132E-8D41-95950C8A9076}"/>
              </a:ext>
            </a:extLst>
          </p:cNvPr>
          <p:cNvCxnSpPr/>
          <p:nvPr/>
        </p:nvCxnSpPr>
        <p:spPr>
          <a:xfrm>
            <a:off x="984587" y="2908663"/>
            <a:ext cx="0" cy="1445622"/>
          </a:xfrm>
          <a:prstGeom prst="straightConnector1">
            <a:avLst/>
          </a:prstGeom>
          <a:ln w="19050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F0C6E00-0213-C711-1B6F-55D1990EB67A}"/>
              </a:ext>
            </a:extLst>
          </p:cNvPr>
          <p:cNvSpPr txBox="1"/>
          <p:nvPr/>
        </p:nvSpPr>
        <p:spPr>
          <a:xfrm>
            <a:off x="580123" y="4467495"/>
            <a:ext cx="8002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Baseline </a:t>
            </a:r>
          </a:p>
          <a:p>
            <a:pPr algn="ctr"/>
            <a:r>
              <a:rPr lang="en-US" sz="1000" dirty="0"/>
              <a:t>(before C1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4E0CAFB-4F93-22CA-D815-6B4B3DF8435F}"/>
              </a:ext>
            </a:extLst>
          </p:cNvPr>
          <p:cNvSpPr txBox="1"/>
          <p:nvPr/>
        </p:nvSpPr>
        <p:spPr>
          <a:xfrm>
            <a:off x="770880" y="253933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0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FC5F0821-22F8-8DD0-6686-C2FABE7C6C3C}"/>
              </a:ext>
            </a:extLst>
          </p:cNvPr>
          <p:cNvCxnSpPr/>
          <p:nvPr/>
        </p:nvCxnSpPr>
        <p:spPr>
          <a:xfrm>
            <a:off x="2565193" y="2908663"/>
            <a:ext cx="0" cy="1445622"/>
          </a:xfrm>
          <a:prstGeom prst="straightConnector1">
            <a:avLst/>
          </a:prstGeom>
          <a:ln w="19050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A70D727C-0CC0-281A-0FAD-C5248966A122}"/>
              </a:ext>
            </a:extLst>
          </p:cNvPr>
          <p:cNvSpPr txBox="1"/>
          <p:nvPr/>
        </p:nvSpPr>
        <p:spPr>
          <a:xfrm>
            <a:off x="2160729" y="4467495"/>
            <a:ext cx="8002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21 days </a:t>
            </a:r>
          </a:p>
          <a:p>
            <a:pPr algn="ctr"/>
            <a:r>
              <a:rPr lang="en-US" sz="1000" dirty="0"/>
              <a:t>(before C2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1C93604-0365-6123-8AD8-02333BF6B91B}"/>
              </a:ext>
            </a:extLst>
          </p:cNvPr>
          <p:cNvSpPr txBox="1"/>
          <p:nvPr/>
        </p:nvSpPr>
        <p:spPr>
          <a:xfrm>
            <a:off x="2351486" y="253933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1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96B615B0-31FE-FA96-D2C5-48DC6A8F36EB}"/>
              </a:ext>
            </a:extLst>
          </p:cNvPr>
          <p:cNvCxnSpPr/>
          <p:nvPr/>
        </p:nvCxnSpPr>
        <p:spPr>
          <a:xfrm>
            <a:off x="4336556" y="2908663"/>
            <a:ext cx="0" cy="1445622"/>
          </a:xfrm>
          <a:prstGeom prst="straightConnector1">
            <a:avLst/>
          </a:prstGeom>
          <a:ln w="19050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F68F3F0D-0782-4179-48BF-67AFDCA352D6}"/>
              </a:ext>
            </a:extLst>
          </p:cNvPr>
          <p:cNvSpPr txBox="1"/>
          <p:nvPr/>
        </p:nvSpPr>
        <p:spPr>
          <a:xfrm>
            <a:off x="3967358" y="4467495"/>
            <a:ext cx="7296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3 months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75D5F91-430F-3E24-0C42-B6B1FB4C4EE2}"/>
              </a:ext>
            </a:extLst>
          </p:cNvPr>
          <p:cNvSpPr txBox="1"/>
          <p:nvPr/>
        </p:nvSpPr>
        <p:spPr>
          <a:xfrm>
            <a:off x="4122849" y="253933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2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B864DC35-E8DE-1520-DBDB-CA4A9D7D7A9D}"/>
              </a:ext>
            </a:extLst>
          </p:cNvPr>
          <p:cNvCxnSpPr/>
          <p:nvPr/>
        </p:nvCxnSpPr>
        <p:spPr>
          <a:xfrm>
            <a:off x="5917162" y="2918766"/>
            <a:ext cx="0" cy="1445622"/>
          </a:xfrm>
          <a:prstGeom prst="straightConnector1">
            <a:avLst/>
          </a:prstGeom>
          <a:ln w="19050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2C7ACD81-FAE6-9A29-D5BB-313617A5CD1A}"/>
              </a:ext>
            </a:extLst>
          </p:cNvPr>
          <p:cNvSpPr txBox="1"/>
          <p:nvPr/>
        </p:nvSpPr>
        <p:spPr>
          <a:xfrm>
            <a:off x="5560788" y="4477598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6 month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00161B2-D940-8CB5-332A-50C7387AD20C}"/>
              </a:ext>
            </a:extLst>
          </p:cNvPr>
          <p:cNvSpPr txBox="1"/>
          <p:nvPr/>
        </p:nvSpPr>
        <p:spPr>
          <a:xfrm>
            <a:off x="5703455" y="254943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3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F4D6AB8-FF38-0416-00A9-F7CE2C48BA7F}"/>
              </a:ext>
            </a:extLst>
          </p:cNvPr>
          <p:cNvCxnSpPr/>
          <p:nvPr/>
        </p:nvCxnSpPr>
        <p:spPr>
          <a:xfrm>
            <a:off x="7502123" y="2918766"/>
            <a:ext cx="0" cy="1445622"/>
          </a:xfrm>
          <a:prstGeom prst="straightConnector1">
            <a:avLst/>
          </a:prstGeom>
          <a:ln w="19050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B2B66774-EA5E-FEDE-BDBB-290210DE2B24}"/>
              </a:ext>
            </a:extLst>
          </p:cNvPr>
          <p:cNvSpPr txBox="1"/>
          <p:nvPr/>
        </p:nvSpPr>
        <p:spPr>
          <a:xfrm>
            <a:off x="7239524" y="4477598"/>
            <a:ext cx="5164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1 yea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FFA25CD-8E42-B5D9-D5C7-250C548F3755}"/>
              </a:ext>
            </a:extLst>
          </p:cNvPr>
          <p:cNvSpPr txBox="1"/>
          <p:nvPr/>
        </p:nvSpPr>
        <p:spPr>
          <a:xfrm>
            <a:off x="7288416" y="254943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4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53DC58A9-84B6-A484-BB8D-E3CE6951BD23}"/>
              </a:ext>
            </a:extLst>
          </p:cNvPr>
          <p:cNvCxnSpPr/>
          <p:nvPr/>
        </p:nvCxnSpPr>
        <p:spPr>
          <a:xfrm>
            <a:off x="11163492" y="2908663"/>
            <a:ext cx="0" cy="1445622"/>
          </a:xfrm>
          <a:prstGeom prst="straightConnector1">
            <a:avLst/>
          </a:prstGeom>
          <a:ln w="19050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E53F9E89-CB92-3A3C-4D3C-EA1A02828E1E}"/>
              </a:ext>
            </a:extLst>
          </p:cNvPr>
          <p:cNvSpPr txBox="1"/>
          <p:nvPr/>
        </p:nvSpPr>
        <p:spPr>
          <a:xfrm>
            <a:off x="10869635" y="4467495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2 yea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245DFDA-78F6-0E4C-E4FC-E2EDEB9F8167}"/>
              </a:ext>
            </a:extLst>
          </p:cNvPr>
          <p:cNvSpPr txBox="1"/>
          <p:nvPr/>
        </p:nvSpPr>
        <p:spPr>
          <a:xfrm>
            <a:off x="10346927" y="2302470"/>
            <a:ext cx="16244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End of clinical </a:t>
            </a:r>
          </a:p>
          <a:p>
            <a:pPr algn="ctr"/>
            <a:r>
              <a:rPr lang="en-US" dirty="0"/>
              <a:t>follow up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4CBB3BB-98FB-4DC3-EAE6-AD586E6D0A48}"/>
              </a:ext>
            </a:extLst>
          </p:cNvPr>
          <p:cNvSpPr/>
          <p:nvPr/>
        </p:nvSpPr>
        <p:spPr>
          <a:xfrm>
            <a:off x="770880" y="1776552"/>
            <a:ext cx="6985132" cy="1122008"/>
          </a:xfrm>
          <a:prstGeom prst="rect">
            <a:avLst/>
          </a:prstGeom>
          <a:noFill/>
          <a:ln>
            <a:solidFill>
              <a:schemeClr val="tx2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D874C40-18CF-7E96-92B5-08E0FD144D27}"/>
              </a:ext>
            </a:extLst>
          </p:cNvPr>
          <p:cNvSpPr txBox="1"/>
          <p:nvPr/>
        </p:nvSpPr>
        <p:spPr>
          <a:xfrm>
            <a:off x="1810914" y="1819589"/>
            <a:ext cx="48107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Timepoints of blood sampling for </a:t>
            </a:r>
          </a:p>
          <a:p>
            <a:pPr algn="ctr"/>
            <a:r>
              <a:rPr lang="en-US" dirty="0"/>
              <a:t>peripheral blood immune markers assessment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49C2EAE4-265A-703C-3D7F-2A275C1FDB16}"/>
              </a:ext>
            </a:extLst>
          </p:cNvPr>
          <p:cNvCxnSpPr/>
          <p:nvPr/>
        </p:nvCxnSpPr>
        <p:spPr>
          <a:xfrm>
            <a:off x="980232" y="5146765"/>
            <a:ext cx="0" cy="209006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93C2CAD0-3E77-7FE2-222C-4B1F2A83557D}"/>
              </a:ext>
            </a:extLst>
          </p:cNvPr>
          <p:cNvCxnSpPr/>
          <p:nvPr/>
        </p:nvCxnSpPr>
        <p:spPr>
          <a:xfrm>
            <a:off x="11159136" y="5142410"/>
            <a:ext cx="0" cy="209006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3F1CEF52-6BC2-E295-8B09-9E0455EF787F}"/>
              </a:ext>
            </a:extLst>
          </p:cNvPr>
          <p:cNvCxnSpPr>
            <a:cxnSpLocks/>
          </p:cNvCxnSpPr>
          <p:nvPr/>
        </p:nvCxnSpPr>
        <p:spPr>
          <a:xfrm flipH="1">
            <a:off x="980232" y="5238690"/>
            <a:ext cx="3685487" cy="12333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6F8AE034-8AFC-6988-838A-86BA34594A62}"/>
              </a:ext>
            </a:extLst>
          </p:cNvPr>
          <p:cNvSpPr txBox="1"/>
          <p:nvPr/>
        </p:nvSpPr>
        <p:spPr>
          <a:xfrm>
            <a:off x="4673765" y="5018162"/>
            <a:ext cx="28341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Clinical follow up at all scheduled </a:t>
            </a:r>
          </a:p>
          <a:p>
            <a:pPr algn="ctr"/>
            <a:r>
              <a:rPr lang="en-US" sz="1400" dirty="0"/>
              <a:t>pembrolizumab infusions (q21)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00B468A-7741-A790-ED5F-E63EE388D4E5}"/>
              </a:ext>
            </a:extLst>
          </p:cNvPr>
          <p:cNvCxnSpPr>
            <a:cxnSpLocks/>
          </p:cNvCxnSpPr>
          <p:nvPr/>
        </p:nvCxnSpPr>
        <p:spPr>
          <a:xfrm flipH="1">
            <a:off x="7497768" y="5238690"/>
            <a:ext cx="3661368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B8B77B45-35C7-A537-BA21-C525BBD86236}"/>
              </a:ext>
            </a:extLst>
          </p:cNvPr>
          <p:cNvSpPr txBox="1"/>
          <p:nvPr/>
        </p:nvSpPr>
        <p:spPr>
          <a:xfrm>
            <a:off x="585848" y="591477"/>
            <a:ext cx="106256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illustration of clinical follow-up schedule and prespecified timepoints for peripheral blood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e markers assessment.</a:t>
            </a:r>
          </a:p>
        </p:txBody>
      </p:sp>
    </p:spTree>
    <p:extLst>
      <p:ext uri="{BB962C8B-B14F-4D97-AF65-F5344CB8AC3E}">
        <p14:creationId xmlns:p14="http://schemas.microsoft.com/office/powerpoint/2010/main" val="18538828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920E60F-4995-1749-F4E3-91401C5AF5B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3403B41-0D82-75AA-93D8-72C54D6A0DE9}"/>
              </a:ext>
            </a:extLst>
          </p:cNvPr>
          <p:cNvSpPr txBox="1"/>
          <p:nvPr/>
        </p:nvSpPr>
        <p:spPr>
          <a:xfrm>
            <a:off x="238826" y="248331"/>
            <a:ext cx="109479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early dynam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, T0–T1) between ‘low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high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baseline values of biochemical </a:t>
            </a:r>
          </a:p>
          <a:p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arameter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9" name="Picture 8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5B990EE8-ADF2-83DA-6133-24F64A9998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825" y="2162621"/>
            <a:ext cx="11169217" cy="181983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22AC0B1-F282-5E0D-0E28-56082562F176}"/>
              </a:ext>
            </a:extLst>
          </p:cNvPr>
          <p:cNvSpPr txBox="1"/>
          <p:nvPr/>
        </p:nvSpPr>
        <p:spPr>
          <a:xfrm>
            <a:off x="397042" y="6471002"/>
            <a:ext cx="71300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means of 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240552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715A00-0282-C529-4058-44A987E59E4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E73FBE3-34D5-EFD3-3919-D73509963DCB}"/>
              </a:ext>
            </a:extLst>
          </p:cNvPr>
          <p:cNvSpPr txBox="1"/>
          <p:nvPr/>
        </p:nvSpPr>
        <p:spPr>
          <a:xfrm>
            <a:off x="238826" y="248331"/>
            <a:ext cx="108069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early dynam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, T0–T2) between ‘low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high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baseline values of biochemical </a:t>
            </a:r>
          </a:p>
          <a:p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arameter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610281B-480A-53AC-1B76-70DEC08028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825" y="2197028"/>
            <a:ext cx="10946287" cy="2120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362525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DA7D4A-84C5-A74E-D639-C6F2B01DFC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027BA60-16E3-444E-C6D8-C74B9DC13886}"/>
              </a:ext>
            </a:extLst>
          </p:cNvPr>
          <p:cNvSpPr txBox="1"/>
          <p:nvPr/>
        </p:nvSpPr>
        <p:spPr>
          <a:xfrm>
            <a:off x="238826" y="248331"/>
            <a:ext cx="10576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early dynam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, T0–T1) between ‘low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high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baseline values of cytokine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15" descr="A collage of graphs&#10;&#10;Description automatically generated">
            <a:extLst>
              <a:ext uri="{FF2B5EF4-FFF2-40B4-BE49-F238E27FC236}">
                <a16:creationId xmlns:a16="http://schemas.microsoft.com/office/drawing/2014/main" id="{83493579-240A-D841-D56D-056738030B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826" y="881058"/>
            <a:ext cx="11479474" cy="4833942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6D57B247-A4E8-C36C-592A-3F63688B69CC}"/>
              </a:ext>
            </a:extLst>
          </p:cNvPr>
          <p:cNvSpPr txBox="1"/>
          <p:nvPr/>
        </p:nvSpPr>
        <p:spPr>
          <a:xfrm>
            <a:off x="397042" y="6471002"/>
            <a:ext cx="71300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means of 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677075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B71F38D-58D0-8BF6-FBD5-75C81EF5FA8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00DE762-25FF-5FFC-B1D2-E6BDC9A1D321}"/>
              </a:ext>
            </a:extLst>
          </p:cNvPr>
          <p:cNvSpPr txBox="1"/>
          <p:nvPr/>
        </p:nvSpPr>
        <p:spPr>
          <a:xfrm>
            <a:off x="238826" y="248331"/>
            <a:ext cx="10576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early dynam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, T0–T2) between ‘low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high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baseline values of cytokine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9E7DF85-515B-E127-83DF-2AF6004C00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826" y="817322"/>
            <a:ext cx="11074729" cy="530805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84BE422-ABA4-2DD9-9A03-671081B289E0}"/>
              </a:ext>
            </a:extLst>
          </p:cNvPr>
          <p:cNvSpPr txBox="1"/>
          <p:nvPr/>
        </p:nvSpPr>
        <p:spPr>
          <a:xfrm>
            <a:off x="397042" y="6471002"/>
            <a:ext cx="71300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means of 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245279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FD6808B-0E9A-4151-8406-B33C526B070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67F7B1-B615-0706-0B3B-0D8CE5FBB1EB}"/>
              </a:ext>
            </a:extLst>
          </p:cNvPr>
          <p:cNvSpPr txBox="1"/>
          <p:nvPr/>
        </p:nvSpPr>
        <p:spPr>
          <a:xfrm>
            <a:off x="238826" y="248331"/>
            <a:ext cx="1131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4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blood counts kinet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) for T0–T1 between ‘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non-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group of diagrams with text&#10;&#10;Description automatically generated with medium confidence">
            <a:extLst>
              <a:ext uri="{FF2B5EF4-FFF2-40B4-BE49-F238E27FC236}">
                <a16:creationId xmlns:a16="http://schemas.microsoft.com/office/drawing/2014/main" id="{CC61C65D-7CDC-C1B8-535F-D812A0FF07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826" y="1121766"/>
            <a:ext cx="10674709" cy="497423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02182A2-1785-F4B8-1061-C9A8A731EC54}"/>
              </a:ext>
            </a:extLst>
          </p:cNvPr>
          <p:cNvSpPr txBox="1"/>
          <p:nvPr/>
        </p:nvSpPr>
        <p:spPr>
          <a:xfrm>
            <a:off x="397042" y="6471002"/>
            <a:ext cx="6835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groups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773888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E23AB5-3C25-B6C2-7542-681562DA20D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F3C1612-812F-703B-9C01-91EC8A92E654}"/>
              </a:ext>
            </a:extLst>
          </p:cNvPr>
          <p:cNvSpPr txBox="1"/>
          <p:nvPr/>
        </p:nvSpPr>
        <p:spPr>
          <a:xfrm>
            <a:off x="238826" y="248331"/>
            <a:ext cx="119531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5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biochemical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s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inet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) for T0–T1 between ‘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non-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4F95540-6F76-7C07-8E91-9028D1D1F425}"/>
              </a:ext>
            </a:extLst>
          </p:cNvPr>
          <p:cNvSpPr txBox="1"/>
          <p:nvPr/>
        </p:nvSpPr>
        <p:spPr>
          <a:xfrm>
            <a:off x="397042" y="6471002"/>
            <a:ext cx="6835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groups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A group of diagrams with text&#10;&#10;Description automatically generated with medium confidence">
            <a:extLst>
              <a:ext uri="{FF2B5EF4-FFF2-40B4-BE49-F238E27FC236}">
                <a16:creationId xmlns:a16="http://schemas.microsoft.com/office/drawing/2014/main" id="{8890F863-A178-C045-41EF-5D37DE4AAB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826" y="979140"/>
            <a:ext cx="8505124" cy="51303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920837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DA8B98-9968-81B8-464C-287FD59E448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22284E-6A48-6F3B-F5FA-E0C4C66939D6}"/>
              </a:ext>
            </a:extLst>
          </p:cNvPr>
          <p:cNvSpPr txBox="1"/>
          <p:nvPr/>
        </p:nvSpPr>
        <p:spPr>
          <a:xfrm>
            <a:off x="238826" y="248331"/>
            <a:ext cx="11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6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cytokines and sPD-L1 kinet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) for T0–T1 between ‘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non-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0579EAC-BDDC-5762-EBBB-690FA117BD54}"/>
              </a:ext>
            </a:extLst>
          </p:cNvPr>
          <p:cNvSpPr txBox="1"/>
          <p:nvPr/>
        </p:nvSpPr>
        <p:spPr>
          <a:xfrm>
            <a:off x="397042" y="6471002"/>
            <a:ext cx="6835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groups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Picture 28" descr="A collage of diagrams&#10;&#10;Description automatically generated">
            <a:extLst>
              <a:ext uri="{FF2B5EF4-FFF2-40B4-BE49-F238E27FC236}">
                <a16:creationId xmlns:a16="http://schemas.microsoft.com/office/drawing/2014/main" id="{D3B33066-0901-F2E3-CD32-B8432498A9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826" y="998449"/>
            <a:ext cx="11215015" cy="50917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308924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BFA047-5ABF-5695-A54D-297303A4B24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F7CDCF7-FC1C-885F-CC6E-4170CC0D4A26}"/>
              </a:ext>
            </a:extLst>
          </p:cNvPr>
          <p:cNvSpPr txBox="1"/>
          <p:nvPr/>
        </p:nvSpPr>
        <p:spPr>
          <a:xfrm>
            <a:off x="238826" y="248331"/>
            <a:ext cx="1131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7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blood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unts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inet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) for T0–T2 between ‘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non-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56F810-98BC-AABD-D44F-ABBFF4999F8C}"/>
              </a:ext>
            </a:extLst>
          </p:cNvPr>
          <p:cNvSpPr txBox="1"/>
          <p:nvPr/>
        </p:nvSpPr>
        <p:spPr>
          <a:xfrm>
            <a:off x="397042" y="6471002"/>
            <a:ext cx="6835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groups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A group of diagrams with text&#10;&#10;Description automatically generated with medium confidence">
            <a:extLst>
              <a:ext uri="{FF2B5EF4-FFF2-40B4-BE49-F238E27FC236}">
                <a16:creationId xmlns:a16="http://schemas.microsoft.com/office/drawing/2014/main" id="{6C210A98-F669-02CD-2CD5-F57209DB48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825" y="868206"/>
            <a:ext cx="11277147" cy="52658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797077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3D0EAB-6E4D-4373-A595-3906301BA18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557D074-4513-C3BA-A27C-2F9BCFD12E60}"/>
              </a:ext>
            </a:extLst>
          </p:cNvPr>
          <p:cNvSpPr txBox="1"/>
          <p:nvPr/>
        </p:nvSpPr>
        <p:spPr>
          <a:xfrm>
            <a:off x="238826" y="248331"/>
            <a:ext cx="119531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8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biochemical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s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inet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) for T0–T2 between ‘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non-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555E28-B8AD-B72B-BE6A-95C1CE1670A7}"/>
              </a:ext>
            </a:extLst>
          </p:cNvPr>
          <p:cNvSpPr txBox="1"/>
          <p:nvPr/>
        </p:nvSpPr>
        <p:spPr>
          <a:xfrm>
            <a:off x="397042" y="6471002"/>
            <a:ext cx="6835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groups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A group of diagrams showing different types of numbers&#10;&#10;Description automatically generated with medium confidence">
            <a:extLst>
              <a:ext uri="{FF2B5EF4-FFF2-40B4-BE49-F238E27FC236}">
                <a16:creationId xmlns:a16="http://schemas.microsoft.com/office/drawing/2014/main" id="{85E28BC1-1256-58F0-4CB8-6C243B0665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042" y="735663"/>
            <a:ext cx="7895524" cy="51426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12899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735976-B1DF-71CE-B900-712ACF9F42E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6AF3A23-EE0F-E55D-71F5-65311752B9FB}"/>
              </a:ext>
            </a:extLst>
          </p:cNvPr>
          <p:cNvSpPr txBox="1"/>
          <p:nvPr/>
        </p:nvSpPr>
        <p:spPr>
          <a:xfrm>
            <a:off x="238826" y="248331"/>
            <a:ext cx="11821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9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cytokines and sPD-L1 kinet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) for T0–T2 between ‘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non-responders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89247DB-4BF8-8CBA-E6EA-6AEB5B86BF93}"/>
              </a:ext>
            </a:extLst>
          </p:cNvPr>
          <p:cNvSpPr txBox="1"/>
          <p:nvPr/>
        </p:nvSpPr>
        <p:spPr>
          <a:xfrm>
            <a:off x="397042" y="6471002"/>
            <a:ext cx="6835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groups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collage of diagrams&#10;&#10;Description automatically generated">
            <a:extLst>
              <a:ext uri="{FF2B5EF4-FFF2-40B4-BE49-F238E27FC236}">
                <a16:creationId xmlns:a16="http://schemas.microsoft.com/office/drawing/2014/main" id="{BF788F23-F12E-9056-271D-E391394D1A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826" y="831159"/>
            <a:ext cx="11533448" cy="54613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47478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2655CE-1EEF-7D8D-58D2-598E2108359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3679CB73-889F-08A4-39FA-C96452550F27}"/>
              </a:ext>
            </a:extLst>
          </p:cNvPr>
          <p:cNvSpPr txBox="1"/>
          <p:nvPr/>
        </p:nvSpPr>
        <p:spPr>
          <a:xfrm>
            <a:off x="304813" y="451262"/>
            <a:ext cx="725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od counts with non-significant fluctuations during treatment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0EE60D9-19C8-8A4C-8EAA-145C28249943}"/>
              </a:ext>
            </a:extLst>
          </p:cNvPr>
          <p:cNvSpPr txBox="1"/>
          <p:nvPr/>
        </p:nvSpPr>
        <p:spPr>
          <a:xfrm>
            <a:off x="304812" y="6318780"/>
            <a:ext cx="5278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performed with the non-parametric Kruskal-Wallis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 descr="A group of graphs showing different types of cells&#10;&#10;Description automatically generated">
            <a:extLst>
              <a:ext uri="{FF2B5EF4-FFF2-40B4-BE49-F238E27FC236}">
                <a16:creationId xmlns:a16="http://schemas.microsoft.com/office/drawing/2014/main" id="{EA0CD6E3-A5D9-F133-4815-BF9ADB6EE6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11" y="1174750"/>
            <a:ext cx="8825627" cy="48626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083170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AB11A37-6454-431A-0053-919857F7AD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D2D0356-9686-2D42-A169-215C097323A6}"/>
              </a:ext>
            </a:extLst>
          </p:cNvPr>
          <p:cNvSpPr txBox="1"/>
          <p:nvPr/>
        </p:nvSpPr>
        <p:spPr>
          <a:xfrm>
            <a:off x="304813" y="451262"/>
            <a:ext cx="670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0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pre-progression dynamics of blood counts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61BB78D-D4F1-EA5E-72C7-1E30AE094A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12" y="2028701"/>
            <a:ext cx="10739239" cy="280474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C5A28B9-DAED-6703-63E3-8187317630B3}"/>
              </a:ext>
            </a:extLst>
          </p:cNvPr>
          <p:cNvSpPr txBox="1"/>
          <p:nvPr/>
        </p:nvSpPr>
        <p:spPr>
          <a:xfrm>
            <a:off x="397042" y="6471002"/>
            <a:ext cx="6835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groups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073667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451CC00-CA98-EE80-F570-39CD36C16B3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AF82CEE-8BD2-BC04-11E7-030C5B4F71E2}"/>
              </a:ext>
            </a:extLst>
          </p:cNvPr>
          <p:cNvSpPr txBox="1"/>
          <p:nvPr/>
        </p:nvSpPr>
        <p:spPr>
          <a:xfrm>
            <a:off x="304813" y="451262"/>
            <a:ext cx="7797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1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pre-progression dynamics for biochemical parameters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97C41CE-8C71-C760-550F-2D7F6C02B5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13" y="1993900"/>
            <a:ext cx="10798616" cy="295458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0750934-9C77-39B5-4688-A5FBE688F7B4}"/>
              </a:ext>
            </a:extLst>
          </p:cNvPr>
          <p:cNvSpPr txBox="1"/>
          <p:nvPr/>
        </p:nvSpPr>
        <p:spPr>
          <a:xfrm>
            <a:off x="397042" y="6471002"/>
            <a:ext cx="6835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groups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022393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BF67F1-1D03-D269-A54C-2C2C22D955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B1F0BD-2DF5-E4F3-45C3-15B5AB4F2A16}"/>
              </a:ext>
            </a:extLst>
          </p:cNvPr>
          <p:cNvSpPr txBox="1"/>
          <p:nvPr/>
        </p:nvSpPr>
        <p:spPr>
          <a:xfrm>
            <a:off x="304813" y="320633"/>
            <a:ext cx="84135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pre-progression dynamics for cytokines and soluble PD-L1.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89A29C80-A035-E69F-7CC8-771A489894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13" y="873263"/>
            <a:ext cx="8849538" cy="559773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DB2C0FA-091F-4FA2-7219-DDE321675A78}"/>
              </a:ext>
            </a:extLst>
          </p:cNvPr>
          <p:cNvSpPr txBox="1"/>
          <p:nvPr/>
        </p:nvSpPr>
        <p:spPr>
          <a:xfrm>
            <a:off x="397042" y="6471002"/>
            <a:ext cx="6835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groups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79081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9CDEC3C-5463-C235-E351-2E8FD4ACD8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D4056E-4A68-E7C0-BBB4-4C3A5AE85072}"/>
              </a:ext>
            </a:extLst>
          </p:cNvPr>
          <p:cNvSpPr txBox="1"/>
          <p:nvPr/>
        </p:nvSpPr>
        <p:spPr>
          <a:xfrm>
            <a:off x="304813" y="451262"/>
            <a:ext cx="81955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chemical parameters with non-significant fluctuations during treatment.</a:t>
            </a:r>
          </a:p>
        </p:txBody>
      </p:sp>
      <p:pic>
        <p:nvPicPr>
          <p:cNvPr id="7" name="Picture 6" descr="A comparison of graphs with numbers&#10;&#10;Description automatically generated with medium confidence">
            <a:extLst>
              <a:ext uri="{FF2B5EF4-FFF2-40B4-BE49-F238E27FC236}">
                <a16:creationId xmlns:a16="http://schemas.microsoft.com/office/drawing/2014/main" id="{B1E4560A-2A93-BA4A-EE5C-8DCB2E1CBD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12" y="1860798"/>
            <a:ext cx="10446013" cy="263995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B1B0EBC-4662-EAFE-F4AE-1BC9F58FD47D}"/>
              </a:ext>
            </a:extLst>
          </p:cNvPr>
          <p:cNvSpPr txBox="1"/>
          <p:nvPr/>
        </p:nvSpPr>
        <p:spPr>
          <a:xfrm>
            <a:off x="304812" y="5966211"/>
            <a:ext cx="5278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performed with the non-parametric Kruskal-Wallis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59024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3E7E02-37A5-050E-335C-47EAB63AF3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B589294-47FB-3BD3-EA60-E006F033AE76}"/>
              </a:ext>
            </a:extLst>
          </p:cNvPr>
          <p:cNvSpPr txBox="1"/>
          <p:nvPr/>
        </p:nvSpPr>
        <p:spPr>
          <a:xfrm>
            <a:off x="304813" y="191770"/>
            <a:ext cx="8708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kines and soluble PD-L1 without significant fluctuations during treatment.</a:t>
            </a:r>
          </a:p>
        </p:txBody>
      </p:sp>
      <p:pic>
        <p:nvPicPr>
          <p:cNvPr id="7" name="Picture 6" descr="A group of graphs showing different types of numbers&#10;&#10;Description automatically generated with medium confidence">
            <a:extLst>
              <a:ext uri="{FF2B5EF4-FFF2-40B4-BE49-F238E27FC236}">
                <a16:creationId xmlns:a16="http://schemas.microsoft.com/office/drawing/2014/main" id="{8722A87C-E37D-7706-B54C-D201163ECB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042" y="667399"/>
            <a:ext cx="10953750" cy="569730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5C088A81-CBC5-9498-F774-C96700827736}"/>
              </a:ext>
            </a:extLst>
          </p:cNvPr>
          <p:cNvSpPr txBox="1"/>
          <p:nvPr/>
        </p:nvSpPr>
        <p:spPr>
          <a:xfrm>
            <a:off x="397042" y="6471002"/>
            <a:ext cx="5278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performed with the non-parametric Kruskal-Wallis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2599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A8D53D5-71F5-24F0-61C3-471512910A0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0855BAE-1121-0389-AD6C-9E7775C0A3F5}"/>
              </a:ext>
            </a:extLst>
          </p:cNvPr>
          <p:cNvSpPr txBox="1"/>
          <p:nvPr/>
        </p:nvSpPr>
        <p:spPr>
          <a:xfrm>
            <a:off x="329540" y="357871"/>
            <a:ext cx="91232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od counts with non-significant early changes (T0–T1 and T0–T2 kinetics).</a:t>
            </a:r>
          </a:p>
        </p:txBody>
      </p:sp>
      <p:pic>
        <p:nvPicPr>
          <p:cNvPr id="3" name="Picture 2" descr="A diagram of cells and monocytes&#10;&#10;Description automatically generated">
            <a:extLst>
              <a:ext uri="{FF2B5EF4-FFF2-40B4-BE49-F238E27FC236}">
                <a16:creationId xmlns:a16="http://schemas.microsoft.com/office/drawing/2014/main" id="{912527CE-8668-8E79-876C-E19CA2B9BF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541" y="1556753"/>
            <a:ext cx="8730238" cy="36079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D62C28B-AD5B-749D-2F3A-EFCBF9200EEA}"/>
              </a:ext>
            </a:extLst>
          </p:cNvPr>
          <p:cNvSpPr txBox="1"/>
          <p:nvPr/>
        </p:nvSpPr>
        <p:spPr>
          <a:xfrm>
            <a:off x="329541" y="5686498"/>
            <a:ext cx="8304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T0-T1 and T0-T2 were performed with the non-parametric Wilcoxon test for paired data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033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215CBA2-AAE5-7F3F-E1CE-55C8C2FAF1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DCE1C3B-6638-1E13-BB0E-08E50C106E5A}"/>
              </a:ext>
            </a:extLst>
          </p:cNvPr>
          <p:cNvSpPr txBox="1"/>
          <p:nvPr/>
        </p:nvSpPr>
        <p:spPr>
          <a:xfrm>
            <a:off x="304813" y="451262"/>
            <a:ext cx="9480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chemical parameters with non-significant early changes (T0–T1 and T0–T2 kinetics).</a:t>
            </a:r>
          </a:p>
        </p:txBody>
      </p:sp>
      <p:pic>
        <p:nvPicPr>
          <p:cNvPr id="3" name="Picture 2" descr="A diagram of a diagram of a number of different types of numbers&#10;&#10;Description automatically generated with medium confidence">
            <a:extLst>
              <a:ext uri="{FF2B5EF4-FFF2-40B4-BE49-F238E27FC236}">
                <a16:creationId xmlns:a16="http://schemas.microsoft.com/office/drawing/2014/main" id="{F73CD702-BFE1-2CE7-47AD-D4B9422CF0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12" y="1697455"/>
            <a:ext cx="9501759" cy="316330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E9787E2-B3B7-6D14-E8F6-9F1F9C48D7C7}"/>
              </a:ext>
            </a:extLst>
          </p:cNvPr>
          <p:cNvSpPr txBox="1"/>
          <p:nvPr/>
        </p:nvSpPr>
        <p:spPr>
          <a:xfrm>
            <a:off x="329541" y="5686498"/>
            <a:ext cx="8304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T0-T1 and T0-T2 were performed with the non-parametric Wilcoxon test for paired data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19456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24F9CA0-6FC4-FDBD-779C-E4A515305DC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62F48F1-DAA7-BD63-7EDF-566CC33CE728}"/>
              </a:ext>
            </a:extLst>
          </p:cNvPr>
          <p:cNvSpPr txBox="1"/>
          <p:nvPr/>
        </p:nvSpPr>
        <p:spPr>
          <a:xfrm>
            <a:off x="304813" y="191770"/>
            <a:ext cx="9852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kines and soluble PD-L1 without significant early changes (T0–T1 and T0–T2 kinetics).</a:t>
            </a:r>
          </a:p>
        </p:txBody>
      </p:sp>
      <p:pic>
        <p:nvPicPr>
          <p:cNvPr id="3" name="Picture 2" descr="A group of blue and white graphs&#10;&#10;Description automatically generated">
            <a:extLst>
              <a:ext uri="{FF2B5EF4-FFF2-40B4-BE49-F238E27FC236}">
                <a16:creationId xmlns:a16="http://schemas.microsoft.com/office/drawing/2014/main" id="{EAA017A1-3449-F749-1F69-16F2E5D71B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13" y="664743"/>
            <a:ext cx="8574492" cy="569044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33FDA0E-F38F-0AA0-2F57-073EDDBFDF40}"/>
              </a:ext>
            </a:extLst>
          </p:cNvPr>
          <p:cNvSpPr txBox="1"/>
          <p:nvPr/>
        </p:nvSpPr>
        <p:spPr>
          <a:xfrm>
            <a:off x="304813" y="6458829"/>
            <a:ext cx="8304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T0-T1 and T0-T2 were performed with the non-parametric Wilcoxon test for paired data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75281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B5F64F8-3316-27F6-EB1E-89D7983E935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BE4DF8A-D251-A765-9DE9-AA1B95383E98}"/>
              </a:ext>
            </a:extLst>
          </p:cNvPr>
          <p:cNvSpPr txBox="1"/>
          <p:nvPr/>
        </p:nvSpPr>
        <p:spPr>
          <a:xfrm>
            <a:off x="238825" y="248331"/>
            <a:ext cx="11565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early dynam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, T0–T1) between ‘low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high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baseline values of blood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unts.</a:t>
            </a:r>
          </a:p>
        </p:txBody>
      </p:sp>
      <p:pic>
        <p:nvPicPr>
          <p:cNvPr id="3" name="Picture 2" descr="A graph of lymphocyte&#10;&#10;Description automatically generated">
            <a:extLst>
              <a:ext uri="{FF2B5EF4-FFF2-40B4-BE49-F238E27FC236}">
                <a16:creationId xmlns:a16="http://schemas.microsoft.com/office/drawing/2014/main" id="{4826D151-B30F-BDBF-6FAB-EBD87C111E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826" y="2074445"/>
            <a:ext cx="11565282" cy="178769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C634588-BE1D-610F-E4AC-DF2EDEC2089E}"/>
              </a:ext>
            </a:extLst>
          </p:cNvPr>
          <p:cNvSpPr txBox="1"/>
          <p:nvPr/>
        </p:nvSpPr>
        <p:spPr>
          <a:xfrm>
            <a:off x="397042" y="6471002"/>
            <a:ext cx="71300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means of 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99673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EA6F05-DDEE-58F9-84CF-8FBABD93D45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A198323-32D6-D505-6E1C-4956A83009A5}"/>
              </a:ext>
            </a:extLst>
          </p:cNvPr>
          <p:cNvSpPr txBox="1"/>
          <p:nvPr/>
        </p:nvSpPr>
        <p:spPr>
          <a:xfrm>
            <a:off x="238825" y="248331"/>
            <a:ext cx="11479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.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early dynamics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Δ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%, T0–T2) between ‘low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‘high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baseline values of blood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unt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A39940E-806B-8231-D799-A78AA38ED9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826" y="2267994"/>
            <a:ext cx="11310800" cy="179600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24E7798-2C75-4736-E751-001A625CF0A2}"/>
              </a:ext>
            </a:extLst>
          </p:cNvPr>
          <p:cNvSpPr txBox="1"/>
          <p:nvPr/>
        </p:nvSpPr>
        <p:spPr>
          <a:xfrm>
            <a:off x="397042" y="6471002"/>
            <a:ext cx="71300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omparisons between means of 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with the non-parametric Mann-Whitney test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2763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75</TotalTime>
  <Words>766</Words>
  <Application>Microsoft Office PowerPoint</Application>
  <PresentationFormat>Widescreen</PresentationFormat>
  <Paragraphs>70</Paragraphs>
  <Slides>22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Trontzas</dc:creator>
  <cp:lastModifiedBy>MDPI</cp:lastModifiedBy>
  <cp:revision>61</cp:revision>
  <dcterms:created xsi:type="dcterms:W3CDTF">2025-08-18T18:46:44Z</dcterms:created>
  <dcterms:modified xsi:type="dcterms:W3CDTF">2026-05-16T09:20:18Z</dcterms:modified>
</cp:coreProperties>
</file>